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86" d="100"/>
          <a:sy n="86" d="100"/>
        </p:scale>
        <p:origin x="-92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5005" cy="450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16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3361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16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3138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16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7406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16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1728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16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39284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16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4443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16/08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6081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16/08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1042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16/08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2997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16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2020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16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9542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D14C91-A375-40F7-B834-35EFBF51A89C}" type="datetimeFigureOut">
              <a:rPr lang="en-GB" smtClean="0"/>
              <a:t>16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02745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55896578"/>
              </p:ext>
            </p:extLst>
          </p:nvPr>
        </p:nvGraphicFramePr>
        <p:xfrm>
          <a:off x="1781690" y="1382867"/>
          <a:ext cx="5286110" cy="26102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CS ChemDraw Drawing" r:id="rId3" imgW="6872992" imgH="3401190" progId="ChemDraw.Document.6.0">
                  <p:embed/>
                </p:oleObj>
              </mc:Choice>
              <mc:Fallback>
                <p:oleObj name="CS ChemDraw Drawing" r:id="rId3" imgW="6872992" imgH="3401190" progId="ChemDraw.Document.6.0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81690" y="1382867"/>
                        <a:ext cx="5286110" cy="261029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Rectangle 3"/>
          <p:cNvSpPr>
            <a:spLocks noChangeArrowheads="1"/>
          </p:cNvSpPr>
          <p:nvPr/>
        </p:nvSpPr>
        <p:spPr bwMode="auto">
          <a:xfrm rot="10800000" flipV="1">
            <a:off x="1601670" y="4398202"/>
            <a:ext cx="6237185" cy="830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GB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mbria" pitchFamily="18" charset="0"/>
                <a:ea typeface="Calibri" pitchFamily="34" charset="0"/>
                <a:cs typeface="Times New Roman" pitchFamily="18" charset="0"/>
              </a:rPr>
              <a:t>Figure S1: Synthesis of SCYX-6759, Oxaborole-1 and Oxaborole-2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mbria" pitchFamily="18" charset="0"/>
                <a:ea typeface="Calibri" pitchFamily="34" charset="0"/>
                <a:cs typeface="Times New Roman" pitchFamily="18" charset="0"/>
              </a:rPr>
              <a:t>.  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Reagents and conditions; a) DIPEA, 4-F-2-CF</a:t>
            </a:r>
            <a:r>
              <a:rPr kumimoji="0" lang="en-GB" altLang="en-US" sz="1200" b="0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3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-benzoyl chloride, THF, 0ºC-room temp., 16 h, 44%; b) DIPEA, PhSO</a:t>
            </a:r>
            <a:r>
              <a:rPr kumimoji="0" lang="en-GB" altLang="en-US" sz="1200" b="0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2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Cl, THF/</a:t>
            </a:r>
            <a:r>
              <a:rPr kumimoji="0" lang="en-GB" alt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MeCN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room temp., 16 h, 67%; c) DIC, </a:t>
            </a:r>
            <a:r>
              <a:rPr kumimoji="0" lang="en-GB" alt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pentafluorophenol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</a:t>
            </a:r>
            <a:r>
              <a:rPr kumimoji="0" lang="en-GB" alt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DMAc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</a:t>
            </a:r>
            <a:r>
              <a:rPr lang="en-GB" altLang="en-US" sz="1200" dirty="0"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0ºC-room 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temp., 64 h, 67%; d) DIPEA, </a:t>
            </a:r>
            <a:r>
              <a:rPr kumimoji="0" lang="en-GB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II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THF, </a:t>
            </a:r>
            <a:r>
              <a:rPr lang="en-GB" altLang="en-US" sz="1200" dirty="0"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0ºC-room 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temp., 16 h, 3%.</a:t>
            </a:r>
            <a:endParaRPr kumimoji="0" lang="en-GB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56936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80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CS ChemDraw Drawing</vt:lpstr>
      <vt:lpstr>PowerPoint Presentation</vt:lpstr>
    </vt:vector>
  </TitlesOfParts>
  <Company>University of Dunde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Fairlamb</dc:creator>
  <cp:lastModifiedBy>Alan Fairlamb</cp:lastModifiedBy>
  <cp:revision>2</cp:revision>
  <dcterms:created xsi:type="dcterms:W3CDTF">2015-08-14T13:23:41Z</dcterms:created>
  <dcterms:modified xsi:type="dcterms:W3CDTF">2015-08-16T14:37:27Z</dcterms:modified>
</cp:coreProperties>
</file>